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59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1CADE-AAB3-42C0-B511-F5B685713FAB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6B4FD-EA34-4673-A0DD-68B4CBFF35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01850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1CADE-AAB3-42C0-B511-F5B685713FAB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6B4FD-EA34-4673-A0DD-68B4CBFF35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6979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1CADE-AAB3-42C0-B511-F5B685713FAB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6B4FD-EA34-4673-A0DD-68B4CBFF35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45390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1CADE-AAB3-42C0-B511-F5B685713FAB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6B4FD-EA34-4673-A0DD-68B4CBFF35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7168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1CADE-AAB3-42C0-B511-F5B685713FAB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6B4FD-EA34-4673-A0DD-68B4CBFF35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3864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1CADE-AAB3-42C0-B511-F5B685713FAB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6B4FD-EA34-4673-A0DD-68B4CBFF35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62950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1CADE-AAB3-42C0-B511-F5B685713FAB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6B4FD-EA34-4673-A0DD-68B4CBFF35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56115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1CADE-AAB3-42C0-B511-F5B685713FAB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6B4FD-EA34-4673-A0DD-68B4CBFF35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2254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1CADE-AAB3-42C0-B511-F5B685713FAB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6B4FD-EA34-4673-A0DD-68B4CBFF35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05027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1CADE-AAB3-42C0-B511-F5B685713FAB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6B4FD-EA34-4673-A0DD-68B4CBFF35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2137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1CADE-AAB3-42C0-B511-F5B685713FAB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6B4FD-EA34-4673-A0DD-68B4CBFF35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2059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A1CADE-AAB3-42C0-B511-F5B685713FAB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96B4FD-EA34-4673-A0DD-68B4CBFF35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75381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605" y="212915"/>
            <a:ext cx="3600000" cy="36000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9411" y="212915"/>
            <a:ext cx="3600000" cy="360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61217" y="212915"/>
            <a:ext cx="3600000" cy="3600000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4624433" y="4537697"/>
            <a:ext cx="26499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5a-Ctrl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4130152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696" y="515125"/>
            <a:ext cx="3600000" cy="3600000"/>
          </a:xfr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0124" y="515125"/>
            <a:ext cx="3600000" cy="360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87552" y="515125"/>
            <a:ext cx="3600000" cy="3600000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4337162" y="4463534"/>
            <a:ext cx="270125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5a-</a:t>
            </a:r>
            <a:r>
              <a:rPr lang="en-US" altLang="zh-CN" dirty="0" smtClean="0"/>
              <a:t>NG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356021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806" y="646166"/>
            <a:ext cx="3600000" cy="3600000"/>
          </a:xfr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3800" y="646166"/>
            <a:ext cx="3600000" cy="360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15794" y="646166"/>
            <a:ext cx="3600000" cy="3600000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4379137" y="4716083"/>
            <a:ext cx="29304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5a-</a:t>
            </a:r>
            <a:r>
              <a:rPr lang="en-US" altLang="zh-CN" dirty="0" smtClean="0"/>
              <a:t>SCNG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5154719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702" y="435419"/>
            <a:ext cx="5004545" cy="3600000"/>
          </a:xfr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56361" y="435419"/>
            <a:ext cx="5004545" cy="3600000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1342942" y="4385157"/>
            <a:ext cx="26611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5b-Ctrl</a:t>
            </a:r>
            <a:endParaRPr lang="zh-CN" altLang="en-US" dirty="0"/>
          </a:p>
        </p:txBody>
      </p:sp>
      <p:sp>
        <p:nvSpPr>
          <p:cNvPr id="8" name="矩形 7"/>
          <p:cNvSpPr/>
          <p:nvPr/>
        </p:nvSpPr>
        <p:spPr>
          <a:xfrm>
            <a:off x="6928044" y="4324197"/>
            <a:ext cx="27124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5b-</a:t>
            </a:r>
            <a:r>
              <a:rPr lang="en-US" altLang="zh-CN" dirty="0" smtClean="0"/>
              <a:t>NG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1049614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36633" y="365125"/>
            <a:ext cx="5004545" cy="3600000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4820570" y="4245820"/>
            <a:ext cx="29417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5b-</a:t>
            </a:r>
            <a:r>
              <a:rPr lang="en-US" altLang="zh-CN" dirty="0" smtClean="0"/>
              <a:t>SCNG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7645700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602197" y="365125"/>
            <a:ext cx="4536000" cy="3600000"/>
          </a:xfr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6660" y="365125"/>
            <a:ext cx="4536000" cy="360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35517" y="365125"/>
            <a:ext cx="4536000" cy="3600000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536360" y="4263236"/>
            <a:ext cx="263713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5c-Ctrl</a:t>
            </a:r>
            <a:endParaRPr lang="zh-CN" altLang="en-US" dirty="0"/>
          </a:p>
        </p:txBody>
      </p:sp>
      <p:sp>
        <p:nvSpPr>
          <p:cNvPr id="8" name="矩形 7"/>
          <p:cNvSpPr/>
          <p:nvPr/>
        </p:nvSpPr>
        <p:spPr>
          <a:xfrm>
            <a:off x="4646806" y="4263236"/>
            <a:ext cx="26884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5c-</a:t>
            </a:r>
            <a:r>
              <a:rPr lang="en-US" altLang="zh-CN" dirty="0" smtClean="0"/>
              <a:t>NGs</a:t>
            </a:r>
            <a:endParaRPr lang="zh-CN" altLang="en-US" dirty="0"/>
          </a:p>
        </p:txBody>
      </p:sp>
      <p:sp>
        <p:nvSpPr>
          <p:cNvPr id="9" name="矩形 8"/>
          <p:cNvSpPr/>
          <p:nvPr/>
        </p:nvSpPr>
        <p:spPr>
          <a:xfrm>
            <a:off x="8716668" y="4263236"/>
            <a:ext cx="291765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5c-</a:t>
            </a:r>
            <a:r>
              <a:rPr lang="en-US" altLang="zh-CN" dirty="0" smtClean="0"/>
              <a:t>SCNG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8979972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72</Words>
  <Application>Microsoft Office PowerPoint</Application>
  <PresentationFormat>宽屏</PresentationFormat>
  <Paragraphs>9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霞</dc:creator>
  <cp:lastModifiedBy>王 霞</cp:lastModifiedBy>
  <cp:revision>1</cp:revision>
  <dcterms:created xsi:type="dcterms:W3CDTF">2018-11-11T13:59:51Z</dcterms:created>
  <dcterms:modified xsi:type="dcterms:W3CDTF">2018-11-11T14:04:59Z</dcterms:modified>
</cp:coreProperties>
</file>